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8" autoAdjust="0"/>
    <p:restoredTop sz="94660"/>
  </p:normalViewPr>
  <p:slideViewPr>
    <p:cSldViewPr snapToGrid="0">
      <p:cViewPr varScale="1">
        <p:scale>
          <a:sx n="70" d="100"/>
          <a:sy n="70" d="100"/>
        </p:scale>
        <p:origin x="117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良司 小柴" userId="5fbb123de75a2fde" providerId="LiveId" clId="{8ED1EFCC-2830-43B8-86CF-0415119CB01E}"/>
    <pc:docChg chg="undo custSel modSld">
      <pc:chgData name="良司 小柴" userId="5fbb123de75a2fde" providerId="LiveId" clId="{8ED1EFCC-2830-43B8-86CF-0415119CB01E}" dt="2024-05-01T07:33:54.803" v="31" actId="1037"/>
      <pc:docMkLst>
        <pc:docMk/>
      </pc:docMkLst>
      <pc:sldChg chg="modSp mod">
        <pc:chgData name="良司 小柴" userId="5fbb123de75a2fde" providerId="LiveId" clId="{8ED1EFCC-2830-43B8-86CF-0415119CB01E}" dt="2024-05-01T07:33:54.803" v="31" actId="1037"/>
        <pc:sldMkLst>
          <pc:docMk/>
          <pc:sldMk cId="3883304207" sldId="258"/>
        </pc:sldMkLst>
        <pc:graphicFrameChg chg="mod modGraphic">
          <ac:chgData name="良司 小柴" userId="5fbb123de75a2fde" providerId="LiveId" clId="{8ED1EFCC-2830-43B8-86CF-0415119CB01E}" dt="2024-05-01T07:33:54.803" v="31" actId="1037"/>
          <ac:graphicFrameMkLst>
            <pc:docMk/>
            <pc:sldMk cId="3883304207" sldId="258"/>
            <ac:graphicFrameMk id="4" creationId="{DEE88A7C-D75E-1761-D755-21E62E454D02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ADE6D-7177-4523-BD53-203A93C59D93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AC67B-89D0-4EE2-B13D-934B9C173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105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ADE6D-7177-4523-BD53-203A93C59D93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AC67B-89D0-4EE2-B13D-934B9C173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6123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ADE6D-7177-4523-BD53-203A93C59D93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AC67B-89D0-4EE2-B13D-934B9C173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1890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ADE6D-7177-4523-BD53-203A93C59D93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AC67B-89D0-4EE2-B13D-934B9C173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10383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ADE6D-7177-4523-BD53-203A93C59D93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AC67B-89D0-4EE2-B13D-934B9C173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787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ADE6D-7177-4523-BD53-203A93C59D93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AC67B-89D0-4EE2-B13D-934B9C173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2105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ADE6D-7177-4523-BD53-203A93C59D93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AC67B-89D0-4EE2-B13D-934B9C173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9865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ADE6D-7177-4523-BD53-203A93C59D93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AC67B-89D0-4EE2-B13D-934B9C173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9058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ADE6D-7177-4523-BD53-203A93C59D93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AC67B-89D0-4EE2-B13D-934B9C173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4199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ADE6D-7177-4523-BD53-203A93C59D93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AC67B-89D0-4EE2-B13D-934B9C173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48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ADE6D-7177-4523-BD53-203A93C59D93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AC67B-89D0-4EE2-B13D-934B9C173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1741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FADE6D-7177-4523-BD53-203A93C59D93}" type="datetimeFigureOut">
              <a:rPr kumimoji="1" lang="ja-JP" altLang="en-US" smtClean="0"/>
              <a:t>2024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BAC67B-89D0-4EE2-B13D-934B9C173D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375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DEE88A7C-D75E-1761-D755-21E62E454D0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943910870"/>
              </p:ext>
            </p:extLst>
          </p:nvPr>
        </p:nvGraphicFramePr>
        <p:xfrm>
          <a:off x="175122" y="1074018"/>
          <a:ext cx="8775468" cy="44958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82501">
                  <a:extLst>
                    <a:ext uri="{9D8B030D-6E8A-4147-A177-3AD203B41FA5}">
                      <a16:colId xmlns:a16="http://schemas.microsoft.com/office/drawing/2014/main" val="4099683144"/>
                    </a:ext>
                  </a:extLst>
                </a:gridCol>
                <a:gridCol w="2035493">
                  <a:extLst>
                    <a:ext uri="{9D8B030D-6E8A-4147-A177-3AD203B41FA5}">
                      <a16:colId xmlns:a16="http://schemas.microsoft.com/office/drawing/2014/main" val="2158809324"/>
                    </a:ext>
                  </a:extLst>
                </a:gridCol>
                <a:gridCol w="2243455">
                  <a:extLst>
                    <a:ext uri="{9D8B030D-6E8A-4147-A177-3AD203B41FA5}">
                      <a16:colId xmlns:a16="http://schemas.microsoft.com/office/drawing/2014/main" val="3200196968"/>
                    </a:ext>
                  </a:extLst>
                </a:gridCol>
                <a:gridCol w="914019">
                  <a:extLst>
                    <a:ext uri="{9D8B030D-6E8A-4147-A177-3AD203B41FA5}">
                      <a16:colId xmlns:a16="http://schemas.microsoft.com/office/drawing/2014/main" val="1044727837"/>
                    </a:ext>
                  </a:extLst>
                </a:gridCol>
              </a:tblGrid>
              <a:tr h="370840">
                <a:tc gridSpan="4"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</a:rPr>
                        <a:t>S2 Table.</a:t>
                      </a:r>
                      <a:r>
                        <a:rPr kumimoji="1" lang="ja-JP" altLang="en-US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</a:rPr>
                        <a:t>Baseline characteristics between the remission group and the non-remission group at week 4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27166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Number of patients, n (%)</a:t>
                      </a:r>
                      <a:endParaRPr lang="ja-JP" alt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66675" algn="ctr"/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emission group</a:t>
                      </a:r>
                      <a:r>
                        <a:rPr lang="ja-JP" altLang="en-US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　</a:t>
                      </a:r>
                      <a:endParaRPr lang="en-US" alt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indent="66675" algn="ctr"/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1</a:t>
                      </a:r>
                      <a:endParaRPr lang="ja-JP" alt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66675" algn="ctr"/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Non-remission group</a:t>
                      </a:r>
                    </a:p>
                    <a:p>
                      <a:pPr indent="66675" algn="ctr"/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2</a:t>
                      </a:r>
                      <a:endParaRPr lang="ja-JP" alt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i="1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-value</a:t>
                      </a:r>
                      <a:endParaRPr lang="ja-JP" altLang="ja-JP" sz="1600" b="0" kern="100" dirty="0">
                        <a:effectLst/>
                        <a:latin typeface="Palatino Linotype" panose="0204050205050503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34246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Duration of disease</a:t>
                      </a:r>
                      <a:r>
                        <a:rPr lang="ja-JP" altLang="en-US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≦ 5years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7 (33.3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6 (50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0.46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963783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6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Duration of disease 5-10years</a:t>
                      </a:r>
                    </a:p>
                  </a:txBody>
                  <a:tcPr marL="46588" marR="46588" marT="23119" marB="23119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6 (28.6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5 (41.7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0.471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35239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600" b="0" kern="100" dirty="0"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Duration of disease ≧ 10years</a:t>
                      </a:r>
                    </a:p>
                  </a:txBody>
                  <a:tcPr marL="46588" marR="46588" marT="23119" marB="23119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8 (38.1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1 (8.3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0.107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50246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History of ≧ 2 Molecular target drugs</a:t>
                      </a:r>
                    </a:p>
                  </a:txBody>
                  <a:tcPr marL="46588" marR="46588" marT="23119" marB="23119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13 (61.9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7 (58.3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0.405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44452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Baseline CLR ≦ 3.353 mg/10</a:t>
                      </a:r>
                      <a:r>
                        <a:rPr lang="en-US" altLang="ja-JP" sz="1600" b="0" kern="100" baseline="30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46588" marR="46588" marT="23119" marB="23119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16 (76.2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2 (16.7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0.0014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14712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linical response at Week 4</a:t>
                      </a:r>
                    </a:p>
                  </a:txBody>
                  <a:tcPr marL="46588" marR="46588" marT="23119" marB="23119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15 (71.4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3 (25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0.0075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7569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linical remission at Week 4</a:t>
                      </a:r>
                    </a:p>
                  </a:txBody>
                  <a:tcPr marL="46588" marR="46588" marT="23119" marB="23119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9 (42.9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2 (16.7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0.128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55986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linical response at Week 8</a:t>
                      </a:r>
                    </a:p>
                  </a:txBody>
                  <a:tcPr marL="46588" marR="46588" marT="23119" marB="23119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18 (85.7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4 (33.3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0.0055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64430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kern="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linical remission at Week 8</a:t>
                      </a:r>
                    </a:p>
                  </a:txBody>
                  <a:tcPr marL="46588" marR="46588" marT="23119" marB="23119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13 (61.9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4 (33.3%)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Palatino Linotype" panose="02040502050505030304" pitchFamily="18" charset="0"/>
                        </a:rPr>
                        <a:t>0.157</a:t>
                      </a:r>
                      <a:endParaRPr kumimoji="1" lang="ja-JP" altLang="en-US" sz="16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75303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83304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</TotalTime>
  <Words>158</Words>
  <Application>Microsoft Office PowerPoint</Application>
  <PresentationFormat>画面に合わせる 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良司 小柴</dc:creator>
  <cp:lastModifiedBy>良司 小柴</cp:lastModifiedBy>
  <cp:revision>5</cp:revision>
  <dcterms:created xsi:type="dcterms:W3CDTF">2024-04-30T02:28:40Z</dcterms:created>
  <dcterms:modified xsi:type="dcterms:W3CDTF">2024-05-01T07:34:11Z</dcterms:modified>
</cp:coreProperties>
</file>